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596"/>
    <p:restoredTop sz="96405"/>
  </p:normalViewPr>
  <p:slideViewPr>
    <p:cSldViewPr snapToGrid="0" snapToObjects="1" showGuides="1">
      <p:cViewPr varScale="1">
        <p:scale>
          <a:sx n="125" d="100"/>
          <a:sy n="125" d="100"/>
        </p:scale>
        <p:origin x="168" y="2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57685BF-30F2-1243-A2B3-1D8BCC1537C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C83ADBE9-F3E1-7D49-A443-6893EE374C4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D6CD05D-C80A-274E-AC44-CE23EB37E7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7779F-DD03-FF44-BF23-5797E6025687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EFBBC41-35D0-B343-8CD5-84D21B9516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5DE1F5F-4F36-1147-962B-8AFB69F6D3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700CF-D33A-D549-BA3C-60682CD732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68342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44F648E-1063-D44E-9055-63B0603447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B20D4A90-B61E-5445-B49A-BE9FD6DBA1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B92471A-18D7-E74D-A9B6-064B095B7D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7779F-DD03-FF44-BF23-5797E6025687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52524C4-A5EE-234E-BFC1-B9AF64A5C5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05AB0DC-FB2F-0E44-BFCC-FB82BD269C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700CF-D33A-D549-BA3C-60682CD732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69048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C29FEC5-A30E-CA41-87DC-2C86245A50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BFE83B7-9ACD-944B-9518-B82B310EA52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EBB8DEF-5EF4-D440-B56D-D6A5D437A1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7779F-DD03-FF44-BF23-5797E6025687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C3FED28-D6DD-E841-95C5-A89E8E2E7F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C4B457B-2DB2-104B-B118-67058F2686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700CF-D33A-D549-BA3C-60682CD732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61874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09BC24-6C60-F345-80BF-1BD6709161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8B04CC9-F087-ED41-9C41-51562FBF97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EEB014E-B284-814D-8760-08C9E2A98E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7779F-DD03-FF44-BF23-5797E6025687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546A30F-FBD3-9E40-B1C8-0607E414EB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90A92A3-83D7-BD4B-8069-E6C941B23B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700CF-D33A-D549-BA3C-60682CD732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52369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980CF3E-7698-BA4A-8B57-E3D1E74736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0AA4267-9173-154A-900A-DC77805839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B6DAF27-7509-0841-B55A-22EB1574E3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7779F-DD03-FF44-BF23-5797E6025687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60802B4-AB0C-D342-A03D-679536D6D9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527D208-1A33-6045-8516-962B13322C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700CF-D33A-D549-BA3C-60682CD732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67719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CD6EDA8-3120-2D43-A1C2-C3E2570463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C322E2E-2935-0240-9681-ED89EA9DECE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00FD714-F395-A84F-9A05-F644F95BD7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30A4AD6-67B6-3A47-8385-C9CAAC644D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7779F-DD03-FF44-BF23-5797E6025687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C2232AF-4C39-0240-9DA4-57670CF589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E8475A4-B567-434F-9D65-A26FBB914D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700CF-D33A-D549-BA3C-60682CD732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6046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489CAD9-28EB-2D40-8AF4-9EAA4CA365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14994FE-FB83-BC40-B1DB-231B237BCE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0E3FCEC1-1650-0548-89B0-11DCF08414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2734931-AC5C-9547-996C-5BDB8207043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D4200E0B-C20A-3F4C-BA34-CA7C07756BC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5EC6980-EBB6-0F4A-A148-D4A38D8799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7779F-DD03-FF44-BF23-5797E6025687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A7A7A633-9B3B-3D45-9893-102C63E931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6DAB23D-FB67-674B-9347-01781EA46D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700CF-D33A-D549-BA3C-60682CD732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77139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4E2E78-2683-CF4E-BA4F-D5D87FACD3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237773F-9C23-724C-B879-B6A25CFF58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7779F-DD03-FF44-BF23-5797E6025687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20B6EFD-54C2-784C-9D2C-6D7E4A3FD7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B3EAB6D-7BAF-D049-901F-FA7E59CBE5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700CF-D33A-D549-BA3C-60682CD732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72536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0B207CA-F81B-7F4C-8FA1-1F25852388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7779F-DD03-FF44-BF23-5797E6025687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FBC9835-3010-C94F-A492-CA3085D512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85E9AFC-0DC3-C54A-8328-B89FF1B584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700CF-D33A-D549-BA3C-60682CD732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4252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0A60D37-6A8C-1E43-AE81-A2F7519FE1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DC718A3-C6CC-2B42-AF90-82DBA854AC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46071B4-E69E-234D-9447-5A442EDD1FE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46FA331-F894-8445-9A5C-8A362C59FE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7779F-DD03-FF44-BF23-5797E6025687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969972F-AFEC-184F-B901-AE8738F6B0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92F6C6E-F4AB-0C47-90C8-D98B1DE70D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700CF-D33A-D549-BA3C-60682CD732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6694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A606EB4-A4EA-4C4F-9BA2-E5436DAE75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5B4778F2-346B-8C44-AA1E-891B9C0B5AE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7EAAD4E-1A86-694D-A462-82F02BA1BE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FF65C03-A312-3C4D-B206-C57FA6418B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57779F-DD03-FF44-BF23-5797E6025687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B346C34-9C14-1D4A-A48C-E018BFAD3D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138F0DC-5E9F-E548-82DD-9E3C41C74C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700CF-D33A-D549-BA3C-60682CD732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60786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23134064-B184-6B4D-BB68-53637FFB75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A5F6797-D9C0-C745-863D-290BAE6902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C978783-AE66-EF4F-BA63-2E733D4372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57779F-DD03-FF44-BF23-5797E6025687}" type="datetimeFigureOut">
              <a:rPr kumimoji="1" lang="ja-JP" altLang="en-US" smtClean="0"/>
              <a:t>2021/10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9075A97-7824-034C-97C8-B778FBA7EF9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BFF57BC-CE28-A14C-86EF-82C673C2C58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D700CF-D33A-D549-BA3C-60682CD732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498436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20165441-78C7-FC4B-B24E-CE9742BEF4A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44036559"/>
              </p:ext>
            </p:extLst>
          </p:nvPr>
        </p:nvGraphicFramePr>
        <p:xfrm>
          <a:off x="775856" y="1961499"/>
          <a:ext cx="10659166" cy="2217336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335405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37154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71544">
                  <a:extLst>
                    <a:ext uri="{9D8B030D-6E8A-4147-A177-3AD203B41FA5}">
                      <a16:colId xmlns:a16="http://schemas.microsoft.com/office/drawing/2014/main" val="2945346237"/>
                    </a:ext>
                  </a:extLst>
                </a:gridCol>
                <a:gridCol w="114241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139872">
                  <a:extLst>
                    <a:ext uri="{9D8B030D-6E8A-4147-A177-3AD203B41FA5}">
                      <a16:colId xmlns:a16="http://schemas.microsoft.com/office/drawing/2014/main" val="4281448185"/>
                    </a:ext>
                  </a:extLst>
                </a:gridCol>
                <a:gridCol w="1139872">
                  <a:extLst>
                    <a:ext uri="{9D8B030D-6E8A-4147-A177-3AD203B41FA5}">
                      <a16:colId xmlns:a16="http://schemas.microsoft.com/office/drawing/2014/main" val="2761346070"/>
                    </a:ext>
                  </a:extLst>
                </a:gridCol>
                <a:gridCol w="1139872">
                  <a:extLst>
                    <a:ext uri="{9D8B030D-6E8A-4147-A177-3AD203B41FA5}">
                      <a16:colId xmlns:a16="http://schemas.microsoft.com/office/drawing/2014/main" val="2321717715"/>
                    </a:ext>
                  </a:extLst>
                </a:gridCol>
              </a:tblGrid>
              <a:tr h="314771">
                <a:tc rowSpan="2">
                  <a:txBody>
                    <a:bodyPr/>
                    <a:lstStyle/>
                    <a:p>
                      <a:endParaRPr kumimoji="1" lang="ja-JP" altLang="en-US" sz="1200" b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R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Preterm PROM</a:t>
                      </a:r>
                    </a:p>
                  </a:txBody>
                  <a:tcPr marL="7144" marR="7144" marT="7144" marB="0" anchor="b">
                    <a:lnL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MS PGothic" charset="-128"/>
                        <a:cs typeface="Times New Roman" pitchFamily="18" charset="0"/>
                      </a:endParaRPr>
                    </a:p>
                  </a:txBody>
                  <a:tcPr marL="7144" marR="7144" marT="714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ja-JP" altLang="en-US" sz="14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MS PGothic" charset="-128"/>
                        <a:cs typeface="Times New Roman" pitchFamily="18" charset="0"/>
                      </a:endParaRPr>
                    </a:p>
                  </a:txBody>
                  <a:tcPr marL="7144" marR="7144" marT="714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Preeclampsia</a:t>
                      </a:r>
                      <a:endParaRPr lang="ja-JP" altLang="en-US" sz="12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MS PGothic" charset="-128"/>
                        <a:cs typeface="Times New Roman" pitchFamily="18" charset="0"/>
                      </a:endParaRPr>
                    </a:p>
                  </a:txBody>
                  <a:tcPr marL="7144" marR="7144" marT="7144" marB="0" anchor="b">
                    <a:lnL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MS PGothic" charset="-128"/>
                        <a:cs typeface="Times New Roman" pitchFamily="18" charset="0"/>
                      </a:endParaRPr>
                    </a:p>
                  </a:txBody>
                  <a:tcPr marL="7144" marR="7144" marT="714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itchFamily="18" charset="0"/>
                        <a:ea typeface="MS PGothic" charset="-128"/>
                        <a:cs typeface="Times New Roman" pitchFamily="18" charset="0"/>
                      </a:endParaRPr>
                    </a:p>
                  </a:txBody>
                  <a:tcPr marL="7144" marR="7144" marT="714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81971285"/>
                  </a:ext>
                </a:extLst>
              </a:tr>
              <a:tr h="576586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u="none" strike="noStrike" baseline="0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Preterm PROM (+)</a:t>
                      </a:r>
                    </a:p>
                    <a:p>
                      <a:pPr algn="ctr" fontAlgn="b"/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(</a:t>
                      </a:r>
                      <a:r>
                        <a:rPr lang="en-US" sz="120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n = 7)</a:t>
                      </a:r>
                      <a:endParaRPr lang="en-US" sz="12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MS PGothic" charset="-128"/>
                        <a:cs typeface="Times New Roman" pitchFamily="18" charset="0"/>
                      </a:endParaRPr>
                    </a:p>
                  </a:txBody>
                  <a:tcPr marL="7144" marR="7144" marT="7144" marB="0" anchor="b">
                    <a:lnL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u="none" strike="noStrike" baseline="0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Preterm PROM (-)</a:t>
                      </a:r>
                    </a:p>
                    <a:p>
                      <a:pPr algn="ctr" fontAlgn="b"/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(</a:t>
                      </a:r>
                      <a:r>
                        <a:rPr lang="en-US" sz="120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n = 52)</a:t>
                      </a:r>
                      <a:endParaRPr lang="en-US" sz="12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MS PGothic" charset="-128"/>
                        <a:cs typeface="Times New Roman" pitchFamily="18" charset="0"/>
                      </a:endParaRPr>
                    </a:p>
                  </a:txBody>
                  <a:tcPr marL="7144" marR="7144" marT="714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P</a:t>
                      </a:r>
                      <a:r>
                        <a:rPr lang="ja-JP" altLang="en-US" sz="1200" u="none" strike="noStrike" baseline="0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 </a:t>
                      </a:r>
                      <a:r>
                        <a:rPr lang="en-US" altLang="ja-JP" sz="1200" u="none" strike="noStrike" baseline="0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value</a:t>
                      </a:r>
                      <a:endParaRPr lang="ja-JP" altLang="en-US" sz="12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MS PGothic" charset="-128"/>
                        <a:cs typeface="Times New Roman" pitchFamily="18" charset="0"/>
                      </a:endParaRPr>
                    </a:p>
                  </a:txBody>
                  <a:tcPr marL="7144" marR="7144" marT="7144" marB="0" anchor="b">
                    <a:lnR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eclampsia (+) </a:t>
                      </a:r>
                    </a:p>
                    <a:p>
                      <a:pPr algn="ctr"/>
                      <a:r>
                        <a:rPr kumimoji="1" lang="en-US" altLang="ja-JP" sz="120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 = </a:t>
                      </a:r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)</a:t>
                      </a:r>
                      <a:endParaRPr kumimoji="1" lang="ja-JP" altLang="en-US" sz="120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eclampsia (-) </a:t>
                      </a:r>
                    </a:p>
                    <a:p>
                      <a:pPr algn="ctr"/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n = 54)</a:t>
                      </a:r>
                      <a:endParaRPr kumimoji="1" lang="ja-JP" altLang="en-US" sz="1200" dirty="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dirty="0">
                          <a:solidFill>
                            <a:srgbClr val="FF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 value</a:t>
                      </a:r>
                      <a:endParaRPr kumimoji="1" lang="ja-JP" altLang="en-US" sz="1200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3288277"/>
                  </a:ext>
                </a:extLst>
              </a:tr>
              <a:tr h="441993"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baseline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    Glucocorticoid u</a:t>
                      </a:r>
                      <a:r>
                        <a:rPr lang="en-US" altLang="ja-JP" sz="1200" u="none" strike="noStrike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se,</a:t>
                      </a:r>
                      <a:r>
                        <a:rPr lang="en-US" altLang="ja-JP" sz="1200" u="none" strike="noStrike" baseline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 n (%)</a:t>
                      </a:r>
                      <a:r>
                        <a:rPr lang="en-US" altLang="ja-JP" sz="1200" u="none" strike="noStrike" baseline="3000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##</a:t>
                      </a:r>
                      <a:endParaRPr lang="en-US" altLang="ja-JP" sz="1200" b="0" i="0" u="none" strike="noStrike" baseline="3000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MS PGothic" charset="-128"/>
                        <a:cs typeface="Times New Roman" pitchFamily="18" charset="0"/>
                      </a:endParaRPr>
                    </a:p>
                  </a:txBody>
                  <a:tcPr marL="7144" marR="7144" marT="7144" marB="0" anchor="b">
                    <a:lnR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7 (100.0)</a:t>
                      </a:r>
                      <a:endParaRPr lang="en-US" altLang="ja-JP" sz="12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MS PGothic" charset="-128"/>
                        <a:cs typeface="Times New Roman" pitchFamily="18" charset="0"/>
                      </a:endParaRPr>
                    </a:p>
                  </a:txBody>
                  <a:tcPr marL="7144" marR="7144" marT="7144" marB="0" anchor="b">
                    <a:lnL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42 (80.8)</a:t>
                      </a:r>
                      <a:endParaRPr lang="en-US" altLang="ja-JP" sz="12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MS PGothic" charset="-128"/>
                        <a:cs typeface="Times New Roman" pitchFamily="18" charset="0"/>
                      </a:endParaRPr>
                    </a:p>
                  </a:txBody>
                  <a:tcPr marL="7144" marR="7144" marT="714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0.59</a:t>
                      </a:r>
                      <a:endParaRPr lang="en-US" altLang="ja-JP" sz="12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MS PGothic" charset="-128"/>
                        <a:cs typeface="Times New Roman" pitchFamily="18" charset="0"/>
                      </a:endParaRPr>
                    </a:p>
                  </a:txBody>
                  <a:tcPr marL="7144" marR="7144" marT="7144" marB="0" anchor="b">
                    <a:lnR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5 (100.0)</a:t>
                      </a:r>
                      <a:endParaRPr lang="en-US" altLang="ja-JP" sz="12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MS PGothic" charset="-128"/>
                        <a:cs typeface="Times New Roman" pitchFamily="18" charset="0"/>
                      </a:endParaRPr>
                    </a:p>
                  </a:txBody>
                  <a:tcPr marL="7144" marR="7144" marT="7144" marB="0" anchor="b">
                    <a:lnL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43 (91.1)</a:t>
                      </a:r>
                    </a:p>
                  </a:txBody>
                  <a:tcPr marL="7144" marR="7144" marT="7144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0.58</a:t>
                      </a:r>
                    </a:p>
                  </a:txBody>
                  <a:tcPr marL="7144" marR="7144" marT="7144" marB="0" anchor="b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441993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baseline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    </a:t>
                      </a:r>
                      <a:r>
                        <a:rPr lang="en-US" altLang="ja-JP" sz="1200" u="none" strike="noStrike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Mean</a:t>
                      </a:r>
                      <a:r>
                        <a:rPr lang="en-US" altLang="ja-JP" sz="1200" u="none" strike="noStrike" baseline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 glucocorticoid dose, mg/day</a:t>
                      </a:r>
                      <a:r>
                        <a:rPr lang="en-US" altLang="ja-JP" sz="1200" u="none" strike="noStrike" baseline="3000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#</a:t>
                      </a:r>
                      <a:endParaRPr lang="ja-JP" altLang="en-US" sz="1200" b="0" i="0" u="none" strike="noStrike" baseline="3000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MS PGothic" charset="-128"/>
                        <a:cs typeface="Times New Roman" pitchFamily="18" charset="0"/>
                      </a:endParaRPr>
                    </a:p>
                  </a:txBody>
                  <a:tcPr marL="7144" marR="7144" marT="7144" marB="0" anchor="b">
                    <a:lnR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10.1 </a:t>
                      </a:r>
                      <a:r>
                        <a:rPr kumimoji="1" lang="en-US" sz="1200" b="0" kern="12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 5.3</a:t>
                      </a:r>
                      <a:endParaRPr lang="en-US" altLang="ja-JP" sz="12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MS PGothic" charset="-128"/>
                        <a:cs typeface="Times New Roman" pitchFamily="18" charset="0"/>
                      </a:endParaRPr>
                    </a:p>
                  </a:txBody>
                  <a:tcPr marL="7144" marR="7144" marT="7144" marB="0" anchor="b">
                    <a:lnL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7.9 </a:t>
                      </a:r>
                      <a:r>
                        <a:rPr kumimoji="1" lang="en-US" sz="1200" b="0" kern="12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 4.5</a:t>
                      </a:r>
                      <a:endParaRPr lang="en-US" altLang="ja-JP" sz="12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MS PGothic" charset="-128"/>
                        <a:cs typeface="Times New Roman" pitchFamily="18" charset="0"/>
                      </a:endParaRPr>
                    </a:p>
                  </a:txBody>
                  <a:tcPr marL="7144" marR="7144" marT="7144" marB="0" anchor="b"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0.27</a:t>
                      </a:r>
                    </a:p>
                  </a:txBody>
                  <a:tcPr marL="7144" marR="7144" marT="7144" marB="0" anchor="b">
                    <a:lnR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11.5 </a:t>
                      </a:r>
                      <a:r>
                        <a:rPr kumimoji="1" lang="en-US" sz="1200" b="0" kern="12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en-US" altLang="ja-JP" sz="120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 5.5</a:t>
                      </a:r>
                      <a:endParaRPr lang="en-US" altLang="ja-JP" sz="1200" b="0" i="0" u="none" strike="noStrike" dirty="0"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MS PGothic" charset="-128"/>
                        <a:cs typeface="Times New Roman" pitchFamily="18" charset="0"/>
                      </a:endParaRPr>
                    </a:p>
                  </a:txBody>
                  <a:tcPr marL="7144" marR="7144" marT="7144" marB="0" anchor="b">
                    <a:lnL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7.8 </a:t>
                      </a:r>
                      <a:r>
                        <a:rPr kumimoji="1" lang="en-US" sz="1200" b="0" kern="1200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</a:t>
                      </a:r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 4.5</a:t>
                      </a:r>
                    </a:p>
                  </a:txBody>
                  <a:tcPr marL="7144" marR="7144" marT="7144" marB="0" anchor="b"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0.10</a:t>
                      </a:r>
                    </a:p>
                  </a:txBody>
                  <a:tcPr marL="7144" marR="7144" marT="7144" marB="0" anchor="b"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B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41993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b="0" i="0" u="none" strike="noStrike" baseline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    Increase in the glucocorticoid dose, n (%)</a:t>
                      </a:r>
                      <a:r>
                        <a:rPr lang="en-US" altLang="ja-JP" sz="1200" b="0" i="0" u="none" strike="noStrike" baseline="3000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##</a:t>
                      </a:r>
                      <a:endParaRPr lang="ja-JP" altLang="en-US" sz="1200" b="0" i="0" u="none" strike="noStrike" baseline="3000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latin typeface="Times New Roman" pitchFamily="18" charset="0"/>
                        <a:ea typeface="MS PGothic" charset="-128"/>
                        <a:cs typeface="Times New Roman" pitchFamily="18" charset="0"/>
                      </a:endParaRPr>
                    </a:p>
                  </a:txBody>
                  <a:tcPr marL="7144" marR="7144" marT="7144" marB="0" anchor="b">
                    <a:lnR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4 (57.1)</a:t>
                      </a:r>
                    </a:p>
                  </a:txBody>
                  <a:tcPr marL="7144" marR="7144" marT="7144" marB="0" anchor="b">
                    <a:lnL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8 (15.4)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0.03*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3 (60.0)</a:t>
                      </a:r>
                    </a:p>
                  </a:txBody>
                  <a:tcPr marL="7144" marR="7144" marT="7144" marB="0" anchor="b">
                    <a:lnL w="12700" cap="flat" cmpd="sng" algn="ctr">
                      <a:solidFill>
                        <a:schemeClr val="bg2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8 (15.1)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FF0000"/>
                          </a:solidFill>
                          <a:effectLst/>
                          <a:latin typeface="Times New Roman" pitchFamily="18" charset="0"/>
                          <a:ea typeface="MS PGothic" charset="-128"/>
                          <a:cs typeface="Times New Roman" pitchFamily="18" charset="0"/>
                        </a:rPr>
                        <a:t>0.04*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3175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44552741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0761EF0-C404-C043-9F70-F318142EB478}"/>
              </a:ext>
            </a:extLst>
          </p:cNvPr>
          <p:cNvSpPr txBox="1"/>
          <p:nvPr/>
        </p:nvSpPr>
        <p:spPr>
          <a:xfrm>
            <a:off x="304801" y="4239123"/>
            <a:ext cx="1152698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alues are shown as mean </a:t>
            </a:r>
            <a:r>
              <a:rPr kumimoji="1" lang="en-US" sz="1200" b="0" kern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rPr>
              <a:t>±</a:t>
            </a:r>
            <a:r>
              <a:rPr lang="en-US" altLang="ja-JP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tandard deviation or n (%). </a:t>
            </a:r>
            <a:r>
              <a:rPr lang="en-US" altLang="ja-JP" sz="1200" baseline="30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#</a:t>
            </a:r>
            <a:r>
              <a:rPr lang="en-US" altLang="ja-JP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ilcoxon rank sum test; </a:t>
            </a:r>
            <a:r>
              <a:rPr lang="en-US" altLang="ja-JP" sz="1200" baseline="300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##</a:t>
            </a:r>
            <a:r>
              <a:rPr lang="en-US" altLang="ja-JP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sher’s exact test; *P &lt; 0.05. APOs: adverse </a:t>
            </a:r>
            <a:r>
              <a:rPr lang="en-US" altLang="ja-JP" sz="120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gnancy outcomes;  </a:t>
            </a:r>
            <a:r>
              <a:rPr lang="en-US" altLang="ja-JP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M: premature rupture of the membranes.</a:t>
            </a:r>
            <a:endParaRPr lang="ja-JP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003AD1A-6C85-3941-97E5-5828803B29ED}"/>
              </a:ext>
            </a:extLst>
          </p:cNvPr>
          <p:cNvSpPr txBox="1"/>
          <p:nvPr/>
        </p:nvSpPr>
        <p:spPr>
          <a:xfrm>
            <a:off x="240244" y="1287166"/>
            <a:ext cx="1172956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000" b="1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Supplemental file </a:t>
            </a:r>
            <a:r>
              <a:rPr lang="en-US" altLang="ja-JP" sz="2000" b="1" dirty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1. Associations of glucocorticoid use with PROM and preeclampsia</a:t>
            </a:r>
            <a:endParaRPr lang="ja-JP" altLang="en-US" sz="2000" b="1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260768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8</TotalTime>
  <Words>166</Words>
  <Application>Microsoft Macintosh PowerPoint</Application>
  <PresentationFormat>ワイド画面</PresentationFormat>
  <Paragraphs>3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島田 裕美</dc:creator>
  <cp:lastModifiedBy>島田 裕美</cp:lastModifiedBy>
  <cp:revision>11</cp:revision>
  <dcterms:created xsi:type="dcterms:W3CDTF">2021-10-14T01:21:01Z</dcterms:created>
  <dcterms:modified xsi:type="dcterms:W3CDTF">2021-10-27T09:28:35Z</dcterms:modified>
</cp:coreProperties>
</file>